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omments/comment1.xml" ContentType="application/vnd.openxmlformats-officedocument.presentationml.comments+xml"/>
  <Override PartName="/ppt/comments/comment2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8" r:id="rId2"/>
    <p:sldId id="260" r:id="rId3"/>
    <p:sldId id="263" r:id="rId4"/>
    <p:sldId id="264" r:id="rId5"/>
    <p:sldId id="266" r:id="rId6"/>
    <p:sldId id="265" r:id="rId7"/>
    <p:sldId id="267" r:id="rId8"/>
  </p:sldIdLst>
  <p:sldSz cx="12192000" cy="6858000"/>
  <p:notesSz cx="6889750" cy="1002188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bert Salas Huetos" initials="ASH" lastIdx="3" clrIdx="0">
    <p:extLst>
      <p:ext uri="{19B8F6BF-5375-455C-9EA6-DF929625EA0E}">
        <p15:presenceInfo xmlns:p15="http://schemas.microsoft.com/office/powerpoint/2012/main" userId="S::39923324-Q@epp.urv.cat::cdaea9f7-7d36-42be-9dc5-c17848f3e19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1640" autoAdjust="0"/>
  </p:normalViewPr>
  <p:slideViewPr>
    <p:cSldViewPr snapToGrid="0">
      <p:cViewPr varScale="1">
        <p:scale>
          <a:sx n="105" d="100"/>
          <a:sy n="105" d="100"/>
        </p:scale>
        <p:origin x="132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5-07-08T15:43:14.121" idx="2">
    <p:pos x="7342" y="2843"/>
    <p:text>Try to homogenize the size of every item. Look, there are some weird sizes.</p:text>
    <p:extLst>
      <p:ext uri="{C676402C-5697-4E1C-873F-D02D1690AC5C}">
        <p15:threadingInfo xmlns:p15="http://schemas.microsoft.com/office/powerpoint/2012/main" timeZoneBias="-120"/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5-07-10T09:58:40.548" idx="3">
    <p:pos x="1327" y="26"/>
    <p:text>Two times SFigure 5??</p:text>
    <p:extLst>
      <p:ext uri="{C676402C-5697-4E1C-873F-D02D1690AC5C}">
        <p15:threadingInfo xmlns:p15="http://schemas.microsoft.com/office/powerpoint/2012/main" timeZoneBias="-12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743566-EBE0-419D-885E-58BCB6CEE3AB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8150" y="1252538"/>
            <a:ext cx="601345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822825"/>
            <a:ext cx="5511800" cy="394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20238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2075" y="9520238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6E3050-6076-4FD3-8400-AF629E42D0B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4057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3C274-EF46-A5C2-FE58-4C28DA1A0A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51640D-3505-83DD-36B0-5156AEF006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0EFA6D-A153-B7D7-C890-38614DC32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0EC86-76C1-30B3-B7A1-E1E1BA07C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CD7818-5AA9-89D0-37E1-72A7767F9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3345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43B7B-8499-9250-72DF-4E84567350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199935-1FF9-E571-2C91-5BAF789A99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82A0A-66E9-5711-4EB8-6C3DCD00A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103D75-235A-C7D5-E964-2941283F8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122F85-CD00-80CC-7A5A-EA9AE6E92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6395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5282B5-65BD-B1C6-FEA6-4F7CDFF8C7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5487E1-48BE-F153-ADDA-D7B25A048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721D0F-EFB2-D3FF-A199-81B1189CC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5732A4-B2A3-BD1C-39BC-57DE3E4D2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5E21AC-864B-1C7C-0F57-905A7416C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7899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E6411-5316-4539-974A-0BEFE7A1F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BD3D62-2DA6-EDF7-4C8E-1D53E669C3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E1796B-9404-C8F1-84C4-076FF2A1C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8CD96D-1E71-120A-B997-B81942CD3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B71103-58ED-86CC-84A4-07B7F6F1D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2745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E473D-FBD4-9F2A-D2A6-4FAC6AF9B5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0EDABD-EF96-EC4F-9BAC-90134B71C9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179F95-3C16-940A-D8B7-E87985665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AB6FD8-6410-487B-4C9C-DA53A00CF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CE0FBD-5C28-83D0-DE3F-B28366B97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3968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56956B-A0CD-CA5B-D3C3-EBB6C0254A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AC1FC3-FFD1-AAA1-54BB-5C79A7F7BB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1505F4-51B4-24BF-E9EB-2DAAD6B763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D28152-E8B1-0FAB-0885-98F31219B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86BAFF-1918-A540-0F71-D639C86B8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8A811A-EA01-6C19-D3D9-2CE10045A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5146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6EF5D8-4139-4E5F-8D3C-201A4C28AD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5F714C-BE14-68B8-8DE0-14A00A48C7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787F08-6A03-AE7C-2E86-9DF51374F5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FFB2E9C-3382-141F-2B1B-841D6D162F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34AB1B4-DCDA-1A03-A10F-D58C96DDC9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E5D4A3A-D3DC-FA14-A3A3-C66D610619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E23BF7B-6458-8C88-ED85-E86E879657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B903DC-BC4E-DFD6-C38F-FEF932FF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0971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B19A7-ACFE-10CF-C28A-3E46159C5E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80FB68-1DE1-179D-6629-A1B7E5041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031B8B-512B-8666-2F16-2E505CCBE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8CFB70F-B701-F59F-BCD1-7CEFE8E7C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0197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016034-7BB8-B10E-40ED-6223C29A5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E82B81-3232-C87B-2F31-2D5FF1887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E9512E-B3C9-F160-A622-22468A76EB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7084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2EB1D-B962-B411-3AD8-C810B2E5C0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934C7C-A6BD-55DF-2A2C-3FF1EB95D8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F96302-8DE1-E983-A246-92E6B781B3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D79600-E7D2-299E-3C1D-89A219CA6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7CD3A7-E336-4F04-CC0F-614DBF36E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5E56B6-8BD2-1889-8186-1D4984D9A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3404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9606E5-CD7B-2839-6C5A-C7EEB78259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98E64B-3C8C-B915-BAB8-C7E13A859E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D19204-91A6-4C6B-386C-7FB03D8C65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3D5D05-532C-BBC8-8543-D31172107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FA6022-065A-77DA-55BA-9F8444140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76EAF0-B289-5764-89C6-FE6E36F1F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59070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08C900-FD67-54DC-1AC6-2B3FC82C2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7A1159-1360-6E3E-AE1E-507643596E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4481B1-4210-9E18-02A7-CF1BA4F8BB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2D3A7C-5278-4F98-8F73-4EE261493B32}" type="datetimeFigureOut">
              <a:rPr lang="de-DE" smtClean="0"/>
              <a:t>09.07.2025</a:t>
            </a:fld>
            <a:endParaRPr lang="de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57F5D9-E472-31FE-AF39-01F59705C2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E0BF36-4CE8-F58D-F40D-6062C0F381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AF0134-EE50-4DD8-AC9E-B7804F893FB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9555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omments" Target="../comments/comment1.xm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comments" Target="../comments/comment2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6F1E1D4-7D0F-86DC-3CD9-CC76EE14EFCB}"/>
              </a:ext>
            </a:extLst>
          </p:cNvPr>
          <p:cNvGrpSpPr/>
          <p:nvPr/>
        </p:nvGrpSpPr>
        <p:grpSpPr>
          <a:xfrm>
            <a:off x="2484967" y="40959"/>
            <a:ext cx="9493011" cy="6685459"/>
            <a:chOff x="1791284" y="0"/>
            <a:chExt cx="9493011" cy="6685459"/>
          </a:xfrm>
        </p:grpSpPr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E14ACEBC-DE74-EE6A-609C-847C4D9863AF}"/>
                </a:ext>
              </a:extLst>
            </p:cNvPr>
            <p:cNvGrpSpPr/>
            <p:nvPr/>
          </p:nvGrpSpPr>
          <p:grpSpPr>
            <a:xfrm>
              <a:off x="1791284" y="0"/>
              <a:ext cx="9486136" cy="2166875"/>
              <a:chOff x="82302" y="82833"/>
              <a:chExt cx="9486136" cy="2166875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99CB81DE-B37B-9F49-8663-A30BB95320E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2302" y="89708"/>
                <a:ext cx="5400000" cy="2160000"/>
              </a:xfrm>
              <a:prstGeom prst="rect">
                <a:avLst/>
              </a:prstGeom>
              <a:solidFill>
                <a:schemeClr val="accent2"/>
              </a:solidFill>
              <a:ln>
                <a:noFill/>
              </a:ln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4ECB6EF1-B2A5-AB47-D579-397CBE4B727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428438" y="82833"/>
                <a:ext cx="4140000" cy="2160000"/>
              </a:xfrm>
              <a:prstGeom prst="rect">
                <a:avLst/>
              </a:prstGeom>
              <a:ln>
                <a:noFill/>
              </a:ln>
            </p:spPr>
          </p:pic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37562FC1-2C70-4646-AFD7-E10D403A3773}"/>
                </a:ext>
              </a:extLst>
            </p:cNvPr>
            <p:cNvGrpSpPr/>
            <p:nvPr/>
          </p:nvGrpSpPr>
          <p:grpSpPr>
            <a:xfrm>
              <a:off x="1791284" y="2312375"/>
              <a:ext cx="9493011" cy="2160000"/>
              <a:chOff x="75427" y="4608292"/>
              <a:chExt cx="9493011" cy="2160000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8A9882C3-7EA1-E1E3-2599-77F79564272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5427" y="4608292"/>
                <a:ext cx="5400000" cy="21600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3EA814AD-B71A-6394-9946-FC5B1213E86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428438" y="4608292"/>
                <a:ext cx="4140000" cy="2160000"/>
              </a:xfrm>
              <a:prstGeom prst="rect">
                <a:avLst/>
              </a:prstGeom>
              <a:ln>
                <a:noFill/>
              </a:ln>
            </p:spPr>
          </p:pic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8E49367-EC6A-C6D6-998A-1D037CAC636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812544" y="4525459"/>
              <a:ext cx="2880000" cy="2160000"/>
            </a:xfrm>
            <a:prstGeom prst="rect">
              <a:avLst/>
            </a:prstGeom>
          </p:spPr>
        </p:pic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498A075B-72E9-1860-1CE4-0EABB863A6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91284" y="2156563"/>
              <a:ext cx="9486136" cy="10312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F6C20589-837D-E27D-0E5F-30A2769FC3A7}"/>
                </a:ext>
              </a:extLst>
            </p:cNvPr>
            <p:cNvCxnSpPr>
              <a:cxnSpLocks/>
            </p:cNvCxnSpPr>
            <p:nvPr/>
          </p:nvCxnSpPr>
          <p:spPr>
            <a:xfrm>
              <a:off x="1791284" y="4472375"/>
              <a:ext cx="9486136" cy="0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D78EE29E-68EA-FECA-6125-D058E652E22A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152873" y="4472375"/>
              <a:ext cx="2880000" cy="2160000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FC70681C-7BCA-4587-E5F7-43DB3AB2B4A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082239" y="4472375"/>
              <a:ext cx="2880000" cy="2160000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26646F94-BF2B-205B-F402-B113C7365014}"/>
              </a:ext>
            </a:extLst>
          </p:cNvPr>
          <p:cNvSpPr txBox="1"/>
          <p:nvPr/>
        </p:nvSpPr>
        <p:spPr>
          <a:xfrm>
            <a:off x="3810" y="40959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1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12273113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8D2BF68-F0CA-DD1B-E3E0-038E95FE66D8}"/>
              </a:ext>
            </a:extLst>
          </p:cNvPr>
          <p:cNvGrpSpPr/>
          <p:nvPr/>
        </p:nvGrpSpPr>
        <p:grpSpPr>
          <a:xfrm>
            <a:off x="33331" y="1332032"/>
            <a:ext cx="12125338" cy="4819477"/>
            <a:chOff x="46473" y="89708"/>
            <a:chExt cx="12125338" cy="4819477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84E85EA2-1205-F746-AC08-5A1D8C392AF5}"/>
                </a:ext>
              </a:extLst>
            </p:cNvPr>
            <p:cNvGrpSpPr/>
            <p:nvPr/>
          </p:nvGrpSpPr>
          <p:grpSpPr>
            <a:xfrm>
              <a:off x="86478" y="163264"/>
              <a:ext cx="9360000" cy="1800000"/>
              <a:chOff x="212208" y="397579"/>
              <a:chExt cx="9360000" cy="180000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F03BDAD-DD9D-380D-1467-77725CD7120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12208" y="397579"/>
                <a:ext cx="5400000" cy="1800000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E0078CEE-9223-03DF-0FAC-1B388EDDF96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612208" y="397579"/>
                <a:ext cx="3960000" cy="1800000"/>
              </a:xfrm>
              <a:prstGeom prst="rect">
                <a:avLst/>
              </a:prstGeom>
            </p:spPr>
          </p:pic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B893893-185D-1E7D-8867-196CFD3223C9}"/>
                </a:ext>
              </a:extLst>
            </p:cNvPr>
            <p:cNvGrpSpPr/>
            <p:nvPr/>
          </p:nvGrpSpPr>
          <p:grpSpPr>
            <a:xfrm>
              <a:off x="46473" y="2005184"/>
              <a:ext cx="8557500" cy="2855263"/>
              <a:chOff x="212208" y="2383290"/>
              <a:chExt cx="8557500" cy="2855263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3209ECD8-FFCE-A573-A2A0-23467AEBA036}"/>
                  </a:ext>
                </a:extLst>
              </p:cNvPr>
              <p:cNvGrpSpPr/>
              <p:nvPr/>
            </p:nvGrpSpPr>
            <p:grpSpPr>
              <a:xfrm>
                <a:off x="212208" y="2383290"/>
                <a:ext cx="8557500" cy="1440000"/>
                <a:chOff x="212208" y="2383290"/>
                <a:chExt cx="8557500" cy="1440000"/>
              </a:xfrm>
            </p:grpSpPr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2EBBB390-F7DF-FB5E-332F-63C4374F71F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7149708" y="2383290"/>
                  <a:ext cx="1620000" cy="1440000"/>
                </a:xfrm>
                <a:prstGeom prst="rect">
                  <a:avLst/>
                </a:prstGeom>
              </p:spPr>
            </p:pic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00ADFB80-8AF4-8A98-799C-0BBD648CC0D1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12208" y="2383290"/>
                  <a:ext cx="6840000" cy="1440000"/>
                </a:xfrm>
                <a:prstGeom prst="rect">
                  <a:avLst/>
                </a:prstGeom>
              </p:spPr>
            </p:pic>
          </p:grpSp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BB5E3FFD-32BB-F501-115E-2E88B9095C3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12208" y="3798553"/>
                <a:ext cx="6840000" cy="1440000"/>
              </a:xfrm>
              <a:prstGeom prst="rect">
                <a:avLst/>
              </a:prstGeom>
            </p:spPr>
          </p:pic>
        </p:grp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B170303A-1E22-BB88-AE58-FA487EC0FF4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8022" y="1963263"/>
              <a:ext cx="9318456" cy="15805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23E2E40C-B83A-968C-4CE1-6064BFD5717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446478" y="89708"/>
              <a:ext cx="5174" cy="4749779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E7F23193-9FBD-F7B8-9693-952066573475}"/>
                </a:ext>
              </a:extLst>
            </p:cNvPr>
            <p:cNvCxnSpPr>
              <a:cxnSpLocks/>
            </p:cNvCxnSpPr>
            <p:nvPr/>
          </p:nvCxnSpPr>
          <p:spPr>
            <a:xfrm>
              <a:off x="86072" y="4839487"/>
              <a:ext cx="12029783" cy="69698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18BF7240-AC9D-C336-956A-55AC009FF29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543978" y="878378"/>
              <a:ext cx="2627833" cy="3507933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465B5763-AABB-D03B-D250-19536321E83E}"/>
              </a:ext>
            </a:extLst>
          </p:cNvPr>
          <p:cNvSpPr txBox="1"/>
          <p:nvPr/>
        </p:nvSpPr>
        <p:spPr>
          <a:xfrm>
            <a:off x="3810" y="40959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2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</p:spTree>
    <p:extLst>
      <p:ext uri="{BB962C8B-B14F-4D97-AF65-F5344CB8AC3E}">
        <p14:creationId xmlns:p14="http://schemas.microsoft.com/office/powerpoint/2010/main" val="20607985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206CD10-9993-F71C-2A59-BC99DE62E9E4}"/>
              </a:ext>
            </a:extLst>
          </p:cNvPr>
          <p:cNvSpPr txBox="1"/>
          <p:nvPr/>
        </p:nvSpPr>
        <p:spPr>
          <a:xfrm>
            <a:off x="3810" y="40959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3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EA25874-DC13-E7BF-25B3-A58F742186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703" y="165348"/>
            <a:ext cx="8405295" cy="6527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3718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ECFD306-5FDB-0D6A-B411-179F7F4B50A3}"/>
              </a:ext>
            </a:extLst>
          </p:cNvPr>
          <p:cNvSpPr txBox="1"/>
          <p:nvPr/>
        </p:nvSpPr>
        <p:spPr>
          <a:xfrm>
            <a:off x="3810" y="40959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4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FD6CCE7-8841-6E70-6213-7992F23AA8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3928" y="317958"/>
            <a:ext cx="9270973" cy="61366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9945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95EBFB3-64FB-856B-9F66-A14F7734EA4F}"/>
              </a:ext>
            </a:extLst>
          </p:cNvPr>
          <p:cNvSpPr txBox="1"/>
          <p:nvPr/>
        </p:nvSpPr>
        <p:spPr>
          <a:xfrm>
            <a:off x="0" y="-24068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5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3A72434E-982C-57C3-8367-48500DC92C2B}"/>
              </a:ext>
            </a:extLst>
          </p:cNvPr>
          <p:cNvGrpSpPr/>
          <p:nvPr/>
        </p:nvGrpSpPr>
        <p:grpSpPr>
          <a:xfrm>
            <a:off x="205447" y="442852"/>
            <a:ext cx="11155005" cy="3681695"/>
            <a:chOff x="955886" y="392402"/>
            <a:chExt cx="11155005" cy="368169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0E9CABA-7F4F-23FF-DFF6-9FB5708030E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5886" y="2274097"/>
              <a:ext cx="6840000" cy="1800000"/>
            </a:xfrm>
            <a:prstGeom prst="rect">
              <a:avLst/>
            </a:prstGeom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E65D4B69-D9F8-8E9E-09CF-BCF54A9CC008}"/>
                </a:ext>
              </a:extLst>
            </p:cNvPr>
            <p:cNvGrpSpPr/>
            <p:nvPr/>
          </p:nvGrpSpPr>
          <p:grpSpPr>
            <a:xfrm>
              <a:off x="981110" y="392402"/>
              <a:ext cx="11129781" cy="1800000"/>
              <a:chOff x="981110" y="392402"/>
              <a:chExt cx="11129781" cy="180000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8EB8F79D-8814-822B-E730-CDCADADF0CC7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981110" y="392402"/>
                <a:ext cx="6840000" cy="180000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F339FECE-170F-F4DF-67F3-B76CC82BE57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790891" y="392402"/>
                <a:ext cx="4320000" cy="1800000"/>
              </a:xfrm>
              <a:prstGeom prst="rect">
                <a:avLst/>
              </a:prstGeom>
            </p:spPr>
          </p:pic>
        </p:grpSp>
      </p:grp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BB5AABB1-4081-07D6-26A9-16FF0F71A6EA}"/>
              </a:ext>
            </a:extLst>
          </p:cNvPr>
          <p:cNvCxnSpPr>
            <a:cxnSpLocks/>
          </p:cNvCxnSpPr>
          <p:nvPr/>
        </p:nvCxnSpPr>
        <p:spPr>
          <a:xfrm flipV="1">
            <a:off x="0" y="4206242"/>
            <a:ext cx="12192000" cy="75674"/>
          </a:xfrm>
          <a:prstGeom prst="line">
            <a:avLst/>
          </a:prstGeom>
          <a:ln w="12700" cap="flat" cmpd="sng" algn="ctr">
            <a:solidFill>
              <a:schemeClr val="tx1">
                <a:lumMod val="50000"/>
                <a:lumOff val="50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F50F19B-441A-2574-C637-1212096CCB69}"/>
              </a:ext>
            </a:extLst>
          </p:cNvPr>
          <p:cNvGrpSpPr/>
          <p:nvPr/>
        </p:nvGrpSpPr>
        <p:grpSpPr>
          <a:xfrm>
            <a:off x="230671" y="4363610"/>
            <a:ext cx="11757428" cy="2232681"/>
            <a:chOff x="439542" y="4596939"/>
            <a:chExt cx="11520000" cy="1980000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DD1D4A84-159A-FD21-B5CD-C90B8CC9EF5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9542" y="4596939"/>
              <a:ext cx="6120000" cy="1980000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3BC35B20-A13D-80C9-599A-96D21D86139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559542" y="4596939"/>
              <a:ext cx="5400000" cy="198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390081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425E00D-C433-4A0D-1327-1DA5B93EFAA7}"/>
              </a:ext>
            </a:extLst>
          </p:cNvPr>
          <p:cNvSpPr txBox="1"/>
          <p:nvPr/>
        </p:nvSpPr>
        <p:spPr>
          <a:xfrm>
            <a:off x="3810" y="40959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5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2466C1F-8F19-5934-C760-208D517AB5C0}"/>
              </a:ext>
            </a:extLst>
          </p:cNvPr>
          <p:cNvGrpSpPr/>
          <p:nvPr/>
        </p:nvGrpSpPr>
        <p:grpSpPr>
          <a:xfrm>
            <a:off x="4709833" y="93094"/>
            <a:ext cx="7200000" cy="4290626"/>
            <a:chOff x="99996" y="364261"/>
            <a:chExt cx="7200000" cy="429062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EDC1B9F-5D01-EAC5-3522-D77D821036F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996" y="364261"/>
              <a:ext cx="7200000" cy="21600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6283CF7-AFB1-BA28-9627-B6D19B29ADA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9996" y="2494887"/>
              <a:ext cx="7200000" cy="2160000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960551F-CA11-AE7D-F75D-3410612A6AD4}"/>
              </a:ext>
            </a:extLst>
          </p:cNvPr>
          <p:cNvGrpSpPr/>
          <p:nvPr/>
        </p:nvGrpSpPr>
        <p:grpSpPr>
          <a:xfrm>
            <a:off x="2832899" y="4559432"/>
            <a:ext cx="9050101" cy="2160856"/>
            <a:chOff x="3091451" y="4496372"/>
            <a:chExt cx="9050101" cy="2160856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0F7ACD0-C467-AE73-B940-BA47D47EB34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091451" y="4496372"/>
              <a:ext cx="7200000" cy="216000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1899309-0ACC-2639-98E6-F3AE4B9691D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341552" y="4497228"/>
              <a:ext cx="1800000" cy="2160000"/>
            </a:xfrm>
            <a:prstGeom prst="rect">
              <a:avLst/>
            </a:prstGeom>
          </p:spPr>
        </p:pic>
      </p:grp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120E53F-7E51-C17C-688A-23C489C80F74}"/>
              </a:ext>
            </a:extLst>
          </p:cNvPr>
          <p:cNvCxnSpPr>
            <a:cxnSpLocks/>
          </p:cNvCxnSpPr>
          <p:nvPr/>
        </p:nvCxnSpPr>
        <p:spPr>
          <a:xfrm>
            <a:off x="-50450" y="4420698"/>
            <a:ext cx="12192002" cy="0"/>
          </a:xfrm>
          <a:prstGeom prst="line">
            <a:avLst/>
          </a:prstGeom>
          <a:ln w="12700" cap="flat" cmpd="sng" algn="ctr">
            <a:solidFill>
              <a:schemeClr val="tx1">
                <a:lumMod val="50000"/>
                <a:lumOff val="50000"/>
              </a:schemeClr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177621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005DA1-5EB1-CB52-A94F-63CA1809FF0D}"/>
              </a:ext>
            </a:extLst>
          </p:cNvPr>
          <p:cNvSpPr txBox="1"/>
          <p:nvPr/>
        </p:nvSpPr>
        <p:spPr>
          <a:xfrm>
            <a:off x="3810" y="40959"/>
            <a:ext cx="21024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Bookman Old Style" panose="02050604050505020204" pitchFamily="18" charset="0"/>
                <a:cs typeface="Aldhabi" panose="020B0604020202020204" pitchFamily="2" charset="-78"/>
              </a:rPr>
              <a:t>Supplemental Figure 6</a:t>
            </a:r>
            <a:endParaRPr lang="de-DE" sz="1200" b="1" dirty="0">
              <a:solidFill>
                <a:schemeClr val="tx1">
                  <a:lumMod val="65000"/>
                  <a:lumOff val="35000"/>
                </a:schemeClr>
              </a:solidFill>
              <a:latin typeface="Bookman Old Style" panose="02050604050505020204" pitchFamily="18" charset="0"/>
              <a:cs typeface="Aldhabi" panose="020B0604020202020204" pitchFamily="2" charset="-78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A643BB0-749E-D010-5924-7DB5ADA3B5E4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854846" y="588448"/>
            <a:ext cx="4824250" cy="568110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8A44652-974A-BACD-CD10-83C94F88E6DD}"/>
              </a:ext>
            </a:extLst>
          </p:cNvPr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96000" y="517109"/>
            <a:ext cx="5400000" cy="54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3849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21</Words>
  <Application>Microsoft Office PowerPoint</Application>
  <PresentationFormat>Pantalla panoràmica</PresentationFormat>
  <Paragraphs>7</Paragraphs>
  <Slides>7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Bookman Old Style</vt:lpstr>
      <vt:lpstr>Office Theme</vt:lpstr>
      <vt:lpstr>Presentació del PowerPoint</vt:lpstr>
      <vt:lpstr>Presentació del PowerPoint</vt:lpstr>
      <vt:lpstr>Presentació del PowerPoint</vt:lpstr>
      <vt:lpstr>Presentació del PowerPoint</vt:lpstr>
      <vt:lpstr>Presentació del PowerPoint</vt:lpstr>
      <vt:lpstr>Presentació del PowerPoint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Abu-Halima, Masood</dc:creator>
  <cp:lastModifiedBy>Albert Salas Huetos</cp:lastModifiedBy>
  <cp:revision>70</cp:revision>
  <cp:lastPrinted>2024-12-05T11:53:40Z</cp:lastPrinted>
  <dcterms:created xsi:type="dcterms:W3CDTF">2024-11-26T11:09:16Z</dcterms:created>
  <dcterms:modified xsi:type="dcterms:W3CDTF">2025-07-10T08:02:48Z</dcterms:modified>
</cp:coreProperties>
</file>